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406" r:id="rId2"/>
  </p:sldIdLst>
  <p:sldSz cx="6858000" cy="9906000" type="A4"/>
  <p:notesSz cx="9931400" cy="67945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10" userDrawn="1">
          <p15:clr>
            <a:srgbClr val="A4A3A4"/>
          </p15:clr>
        </p15:guide>
        <p15:guide id="2" pos="391" userDrawn="1">
          <p15:clr>
            <a:srgbClr val="A4A3A4"/>
          </p15:clr>
        </p15:guide>
        <p15:guide id="6" orient="horz" pos="6136" userDrawn="1">
          <p15:clr>
            <a:srgbClr val="A4A3A4"/>
          </p15:clr>
        </p15:guide>
        <p15:guide id="7" pos="3884" userDrawn="1">
          <p15:clr>
            <a:srgbClr val="A4A3A4"/>
          </p15:clr>
        </p15:guide>
        <p15:guide id="8" orient="horz" pos="4435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E09670F-CE05-9C7F-2A18-F12607C6DEEE}" name="Eva Herrero Serrano" initials="EHS" userId="S::eh642@cam.ac.uk::30ee73c8-4441-48c1-9b41-6efa0a64ae52" providerId="AD"/>
  <p188:author id="{14A239CE-EE99-779E-A9A8-70BD1B86BCFC}" name="Alex Webb" initials="AW" userId="S::aarw2@cam.ac.uk::6e034127-e0df-4368-bc35-fbdfd215004d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D92"/>
    <a:srgbClr val="163E62"/>
    <a:srgbClr val="4C95D9"/>
    <a:srgbClr val="46B1E1"/>
    <a:srgbClr val="7A81FF"/>
    <a:srgbClr val="0432FF"/>
    <a:srgbClr val="163E63"/>
    <a:srgbClr val="FF8AD8"/>
    <a:srgbClr val="ECECEC"/>
    <a:srgbClr val="4D95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58"/>
  </p:normalViewPr>
  <p:slideViewPr>
    <p:cSldViewPr snapToGrid="0">
      <p:cViewPr varScale="1">
        <p:scale>
          <a:sx n="80" d="100"/>
          <a:sy n="80" d="100"/>
        </p:scale>
        <p:origin x="3576" y="192"/>
      </p:cViewPr>
      <p:guideLst>
        <p:guide orient="horz" pos="1510"/>
        <p:guide pos="391"/>
        <p:guide orient="horz" pos="6136"/>
        <p:guide pos="3884"/>
        <p:guide orient="horz" pos="44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va Herrero Serrano" userId="30ee73c8-4441-48c1-9b41-6efa0a64ae52" providerId="ADAL" clId="{BB4C00E8-3DFB-AE42-AA0F-CFBDDC05794D}"/>
    <pc:docChg chg="delSld">
      <pc:chgData name="Eva Herrero Serrano" userId="30ee73c8-4441-48c1-9b41-6efa0a64ae52" providerId="ADAL" clId="{BB4C00E8-3DFB-AE42-AA0F-CFBDDC05794D}" dt="2025-07-02T13:30:31.478" v="6" actId="2696"/>
      <pc:docMkLst>
        <pc:docMk/>
      </pc:docMkLst>
      <pc:sldChg chg="del">
        <pc:chgData name="Eva Herrero Serrano" userId="30ee73c8-4441-48c1-9b41-6efa0a64ae52" providerId="ADAL" clId="{BB4C00E8-3DFB-AE42-AA0F-CFBDDC05794D}" dt="2025-07-02T13:30:25.756" v="0" actId="2696"/>
        <pc:sldMkLst>
          <pc:docMk/>
          <pc:sldMk cId="328607546" sldId="384"/>
        </pc:sldMkLst>
      </pc:sldChg>
      <pc:sldChg chg="del">
        <pc:chgData name="Eva Herrero Serrano" userId="30ee73c8-4441-48c1-9b41-6efa0a64ae52" providerId="ADAL" clId="{BB4C00E8-3DFB-AE42-AA0F-CFBDDC05794D}" dt="2025-07-02T13:30:31.478" v="6" actId="2696"/>
        <pc:sldMkLst>
          <pc:docMk/>
          <pc:sldMk cId="2380616195" sldId="400"/>
        </pc:sldMkLst>
      </pc:sldChg>
      <pc:sldChg chg="del">
        <pc:chgData name="Eva Herrero Serrano" userId="30ee73c8-4441-48c1-9b41-6efa0a64ae52" providerId="ADAL" clId="{BB4C00E8-3DFB-AE42-AA0F-CFBDDC05794D}" dt="2025-07-02T13:30:26.504" v="1" actId="2696"/>
        <pc:sldMkLst>
          <pc:docMk/>
          <pc:sldMk cId="548085851" sldId="404"/>
        </pc:sldMkLst>
      </pc:sldChg>
      <pc:sldChg chg="del">
        <pc:chgData name="Eva Herrero Serrano" userId="30ee73c8-4441-48c1-9b41-6efa0a64ae52" providerId="ADAL" clId="{BB4C00E8-3DFB-AE42-AA0F-CFBDDC05794D}" dt="2025-07-02T13:30:26.961" v="2" actId="2696"/>
        <pc:sldMkLst>
          <pc:docMk/>
          <pc:sldMk cId="2152653418" sldId="407"/>
        </pc:sldMkLst>
      </pc:sldChg>
      <pc:sldChg chg="del">
        <pc:chgData name="Eva Herrero Serrano" userId="30ee73c8-4441-48c1-9b41-6efa0a64ae52" providerId="ADAL" clId="{BB4C00E8-3DFB-AE42-AA0F-CFBDDC05794D}" dt="2025-07-02T13:30:27.541" v="3" actId="2696"/>
        <pc:sldMkLst>
          <pc:docMk/>
          <pc:sldMk cId="2384589629" sldId="408"/>
        </pc:sldMkLst>
      </pc:sldChg>
      <pc:sldChg chg="del">
        <pc:chgData name="Eva Herrero Serrano" userId="30ee73c8-4441-48c1-9b41-6efa0a64ae52" providerId="ADAL" clId="{BB4C00E8-3DFB-AE42-AA0F-CFBDDC05794D}" dt="2025-07-02T13:30:28.739" v="5" actId="2696"/>
        <pc:sldMkLst>
          <pc:docMk/>
          <pc:sldMk cId="2625866172" sldId="409"/>
        </pc:sldMkLst>
      </pc:sldChg>
      <pc:sldChg chg="del">
        <pc:chgData name="Eva Herrero Serrano" userId="30ee73c8-4441-48c1-9b41-6efa0a64ae52" providerId="ADAL" clId="{BB4C00E8-3DFB-AE42-AA0F-CFBDDC05794D}" dt="2025-07-02T13:30:28.175" v="4" actId="2696"/>
        <pc:sldMkLst>
          <pc:docMk/>
          <pc:sldMk cId="564929238" sldId="41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3606" cy="3409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5497" y="0"/>
            <a:ext cx="4303606" cy="3409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0B9EA6-4523-204F-A38C-EB310BB9E6E6}" type="datetimeFigureOut">
              <a:rPr lang="en-US" smtClean="0"/>
              <a:t>7/2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171950" y="849313"/>
            <a:ext cx="1587500" cy="2292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3140" y="3269853"/>
            <a:ext cx="7945120" cy="267533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453596"/>
            <a:ext cx="4303606" cy="3409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5497" y="6453596"/>
            <a:ext cx="4303606" cy="3409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B65B47-02A3-6545-81BD-CE096AC3AC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9780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D87EE9-035B-2C41-880D-3874AA92A56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17570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0749-87E1-654D-9347-98A262523D99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366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A369A-2B05-6844-B0A9-E549CABD4D18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881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2C1AE-F068-A54F-BD59-F157D26CAF3B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038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A49AF-D4B1-B841-A3C6-0797BAE97B73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735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EC4B1-A988-4D40-8895-309A5922874F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504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28266-E031-EE4A-AA5B-25E86C1B8835}" type="datetime1">
              <a:rPr lang="en-GB" smtClean="0"/>
              <a:t>02/0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672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81142-A245-CD4C-98EC-FE91F66445E5}" type="datetime1">
              <a:rPr lang="en-GB" smtClean="0"/>
              <a:t>02/0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482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AF423-F805-2041-97CC-1A4994037567}" type="datetime1">
              <a:rPr lang="en-GB" smtClean="0"/>
              <a:t>02/0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045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91740-F340-7F42-A214-B550E62E5598}" type="datetime1">
              <a:rPr lang="en-GB" smtClean="0"/>
              <a:t>02/0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52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21EBA1-5261-ED4A-BA40-688502E8C4F1}" type="datetime1">
              <a:rPr lang="en-GB" smtClean="0"/>
              <a:t>02/0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5866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8212F-31D4-CC4E-BBE9-0FE5E46009E3}" type="datetime1">
              <a:rPr lang="en-GB" smtClean="0"/>
              <a:t>02/0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9610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6F5EBD4-D993-2F4A-BC64-32375B140610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5636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svg"/><Relationship Id="rId5" Type="http://schemas.openxmlformats.org/officeDocument/2006/relationships/image" Target="../media/image3.png"/><Relationship Id="rId4" Type="http://schemas.openxmlformats.org/officeDocument/2006/relationships/image" Target="../media/image2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EA16BD2A-DC73-2E22-F7B8-597CBCC13384}"/>
              </a:ext>
            </a:extLst>
          </p:cNvPr>
          <p:cNvSpPr txBox="1"/>
          <p:nvPr/>
        </p:nvSpPr>
        <p:spPr>
          <a:xfrm>
            <a:off x="251686" y="192224"/>
            <a:ext cx="62919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Extended data Figure 7. TLWD proteins interact with </a:t>
            </a:r>
            <a:r>
              <a:rPr lang="en-US" err="1"/>
              <a:t>Myb</a:t>
            </a:r>
            <a:r>
              <a:rPr lang="en-US"/>
              <a:t>-like transcription factors and control </a:t>
            </a:r>
            <a:r>
              <a:rPr lang="en-US" i="1"/>
              <a:t>TOC1</a:t>
            </a:r>
            <a:r>
              <a:rPr lang="en-US"/>
              <a:t> expression</a:t>
            </a:r>
            <a:endParaRPr lang="en-US" i="1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1330297-C44E-C9B7-2FB7-0A14588ACE45}"/>
              </a:ext>
            </a:extLst>
          </p:cNvPr>
          <p:cNvSpPr txBox="1"/>
          <p:nvPr/>
        </p:nvSpPr>
        <p:spPr>
          <a:xfrm>
            <a:off x="480114" y="862816"/>
            <a:ext cx="415636" cy="338554"/>
          </a:xfrm>
          <a:prstGeom prst="rect">
            <a:avLst/>
          </a:prstGeom>
          <a:noFill/>
        </p:spPr>
        <p:txBody>
          <a:bodyPr wrap="square" lIns="72000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70AF609-D6AB-6F26-C676-A79B5C9E4744}"/>
              </a:ext>
            </a:extLst>
          </p:cNvPr>
          <p:cNvSpPr txBox="1"/>
          <p:nvPr/>
        </p:nvSpPr>
        <p:spPr>
          <a:xfrm>
            <a:off x="480114" y="3298788"/>
            <a:ext cx="415636" cy="338554"/>
          </a:xfrm>
          <a:prstGeom prst="rect">
            <a:avLst/>
          </a:prstGeom>
          <a:noFill/>
        </p:spPr>
        <p:txBody>
          <a:bodyPr wrap="square" lIns="72000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8" name="Graphic 27">
            <a:extLst>
              <a:ext uri="{FF2B5EF4-FFF2-40B4-BE49-F238E27FC236}">
                <a16:creationId xmlns:a16="http://schemas.microsoft.com/office/drawing/2014/main" id="{8CD2A032-E50F-ADCA-15D7-A04EE8898A8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 r="7715"/>
          <a:stretch/>
        </p:blipFill>
        <p:spPr>
          <a:xfrm>
            <a:off x="549275" y="3637342"/>
            <a:ext cx="2880000" cy="2533083"/>
          </a:xfrm>
          <a:prstGeom prst="rect">
            <a:avLst/>
          </a:prstGeom>
        </p:spPr>
      </p:pic>
      <p:pic>
        <p:nvPicPr>
          <p:cNvPr id="5" name="Graphic 4">
            <a:extLst>
              <a:ext uri="{FF2B5EF4-FFF2-40B4-BE49-F238E27FC236}">
                <a16:creationId xmlns:a16="http://schemas.microsoft.com/office/drawing/2014/main" id="{2784A4C7-CCF4-EC1F-35F4-5FB8C6B0A7A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463883" y="1289589"/>
            <a:ext cx="5936005" cy="1776404"/>
          </a:xfrm>
          <a:prstGeom prst="rect">
            <a:avLst/>
          </a:prstGeom>
        </p:spPr>
      </p:pic>
      <p:grpSp>
        <p:nvGrpSpPr>
          <p:cNvPr id="46" name="Group 45">
            <a:extLst>
              <a:ext uri="{FF2B5EF4-FFF2-40B4-BE49-F238E27FC236}">
                <a16:creationId xmlns:a16="http://schemas.microsoft.com/office/drawing/2014/main" id="{CE432106-6785-700B-A52B-89175D5A58C0}"/>
              </a:ext>
            </a:extLst>
          </p:cNvPr>
          <p:cNvGrpSpPr/>
          <p:nvPr/>
        </p:nvGrpSpPr>
        <p:grpSpPr>
          <a:xfrm>
            <a:off x="1147052" y="3042711"/>
            <a:ext cx="291507" cy="199711"/>
            <a:chOff x="1167222" y="3040274"/>
            <a:chExt cx="291507" cy="199711"/>
          </a:xfrm>
        </p:grpSpPr>
        <p:sp>
          <p:nvSpPr>
            <p:cNvPr id="23" name="Right Triangle 22">
              <a:extLst>
                <a:ext uri="{FF2B5EF4-FFF2-40B4-BE49-F238E27FC236}">
                  <a16:creationId xmlns:a16="http://schemas.microsoft.com/office/drawing/2014/main" id="{662B7A92-293E-2C1B-AF1C-59190F6DDCB6}"/>
                </a:ext>
              </a:extLst>
            </p:cNvPr>
            <p:cNvSpPr/>
            <p:nvPr/>
          </p:nvSpPr>
          <p:spPr>
            <a:xfrm>
              <a:off x="1167222" y="3040274"/>
              <a:ext cx="291507" cy="57162"/>
            </a:xfrm>
            <a:prstGeom prst="rtTriangle">
              <a:avLst/>
            </a:prstGeom>
            <a:noFill/>
            <a:ln w="63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33A1D8F-21E2-6284-87EA-9368F21983AE}"/>
                </a:ext>
              </a:extLst>
            </p:cNvPr>
            <p:cNvSpPr txBox="1"/>
            <p:nvPr/>
          </p:nvSpPr>
          <p:spPr>
            <a:xfrm>
              <a:off x="1255536" y="3055319"/>
              <a:ext cx="1042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</p:grpSp>
      <p:grpSp>
        <p:nvGrpSpPr>
          <p:cNvPr id="47" name="Group 46">
            <a:extLst>
              <a:ext uri="{FF2B5EF4-FFF2-40B4-BE49-F238E27FC236}">
                <a16:creationId xmlns:a16="http://schemas.microsoft.com/office/drawing/2014/main" id="{203D1AE8-A4E2-B633-7C85-DDEB58354F86}"/>
              </a:ext>
            </a:extLst>
          </p:cNvPr>
          <p:cNvGrpSpPr/>
          <p:nvPr/>
        </p:nvGrpSpPr>
        <p:grpSpPr>
          <a:xfrm>
            <a:off x="1596638" y="3042711"/>
            <a:ext cx="291507" cy="199711"/>
            <a:chOff x="1583191" y="3040274"/>
            <a:chExt cx="291507" cy="199711"/>
          </a:xfrm>
        </p:grpSpPr>
        <p:sp>
          <p:nvSpPr>
            <p:cNvPr id="24" name="Right Triangle 23">
              <a:extLst>
                <a:ext uri="{FF2B5EF4-FFF2-40B4-BE49-F238E27FC236}">
                  <a16:creationId xmlns:a16="http://schemas.microsoft.com/office/drawing/2014/main" id="{EF2C53CA-708A-9EF6-7D2A-37D904CE9D6D}"/>
                </a:ext>
              </a:extLst>
            </p:cNvPr>
            <p:cNvSpPr/>
            <p:nvPr/>
          </p:nvSpPr>
          <p:spPr>
            <a:xfrm>
              <a:off x="1583191" y="3040274"/>
              <a:ext cx="291507" cy="57162"/>
            </a:xfrm>
            <a:prstGeom prst="rtTriangle">
              <a:avLst/>
            </a:prstGeom>
            <a:noFill/>
            <a:ln w="63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E9D036A9-03BB-00E2-9CCD-13C5F7BE2EB8}"/>
                </a:ext>
              </a:extLst>
            </p:cNvPr>
            <p:cNvSpPr txBox="1"/>
            <p:nvPr/>
          </p:nvSpPr>
          <p:spPr>
            <a:xfrm>
              <a:off x="1660851" y="3055319"/>
              <a:ext cx="1042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28ED7F14-A261-4C1E-C842-4E33AEDE65A3}"/>
              </a:ext>
            </a:extLst>
          </p:cNvPr>
          <p:cNvGrpSpPr/>
          <p:nvPr/>
        </p:nvGrpSpPr>
        <p:grpSpPr>
          <a:xfrm>
            <a:off x="2111127" y="3042711"/>
            <a:ext cx="291507" cy="199711"/>
            <a:chOff x="1167222" y="3040274"/>
            <a:chExt cx="291507" cy="199711"/>
          </a:xfrm>
        </p:grpSpPr>
        <p:sp>
          <p:nvSpPr>
            <p:cNvPr id="49" name="Right Triangle 48">
              <a:extLst>
                <a:ext uri="{FF2B5EF4-FFF2-40B4-BE49-F238E27FC236}">
                  <a16:creationId xmlns:a16="http://schemas.microsoft.com/office/drawing/2014/main" id="{73970BE4-31FF-A64E-6D4B-E12F1FF5C3E9}"/>
                </a:ext>
              </a:extLst>
            </p:cNvPr>
            <p:cNvSpPr/>
            <p:nvPr/>
          </p:nvSpPr>
          <p:spPr>
            <a:xfrm>
              <a:off x="1167222" y="3040274"/>
              <a:ext cx="291507" cy="57162"/>
            </a:xfrm>
            <a:prstGeom prst="rtTriangle">
              <a:avLst/>
            </a:prstGeom>
            <a:noFill/>
            <a:ln w="63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F6AD6A66-DFEE-EEB5-8FB6-71B22C18C99C}"/>
                </a:ext>
              </a:extLst>
            </p:cNvPr>
            <p:cNvSpPr txBox="1"/>
            <p:nvPr/>
          </p:nvSpPr>
          <p:spPr>
            <a:xfrm>
              <a:off x="1255536" y="3055319"/>
              <a:ext cx="1042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</p:grpSp>
      <p:grpSp>
        <p:nvGrpSpPr>
          <p:cNvPr id="51" name="Group 50">
            <a:extLst>
              <a:ext uri="{FF2B5EF4-FFF2-40B4-BE49-F238E27FC236}">
                <a16:creationId xmlns:a16="http://schemas.microsoft.com/office/drawing/2014/main" id="{118856AA-01E9-F0CB-6425-AAB3B6C65CE1}"/>
              </a:ext>
            </a:extLst>
          </p:cNvPr>
          <p:cNvGrpSpPr/>
          <p:nvPr/>
        </p:nvGrpSpPr>
        <p:grpSpPr>
          <a:xfrm>
            <a:off x="2578830" y="3042711"/>
            <a:ext cx="291507" cy="199711"/>
            <a:chOff x="1583191" y="3040274"/>
            <a:chExt cx="291507" cy="199711"/>
          </a:xfrm>
        </p:grpSpPr>
        <p:sp>
          <p:nvSpPr>
            <p:cNvPr id="52" name="Right Triangle 51">
              <a:extLst>
                <a:ext uri="{FF2B5EF4-FFF2-40B4-BE49-F238E27FC236}">
                  <a16:creationId xmlns:a16="http://schemas.microsoft.com/office/drawing/2014/main" id="{A68B3527-CB16-C723-1129-C11E1E4AFFA5}"/>
                </a:ext>
              </a:extLst>
            </p:cNvPr>
            <p:cNvSpPr/>
            <p:nvPr/>
          </p:nvSpPr>
          <p:spPr>
            <a:xfrm>
              <a:off x="1583191" y="3040274"/>
              <a:ext cx="291507" cy="57162"/>
            </a:xfrm>
            <a:prstGeom prst="rtTriangle">
              <a:avLst/>
            </a:prstGeom>
            <a:noFill/>
            <a:ln w="63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79A30D17-8610-ED5D-0354-A9013ED61DE1}"/>
                </a:ext>
              </a:extLst>
            </p:cNvPr>
            <p:cNvSpPr txBox="1"/>
            <p:nvPr/>
          </p:nvSpPr>
          <p:spPr>
            <a:xfrm>
              <a:off x="1660851" y="3055319"/>
              <a:ext cx="1042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6FF2EECC-2461-68B2-515A-C45F224D5507}"/>
              </a:ext>
            </a:extLst>
          </p:cNvPr>
          <p:cNvGrpSpPr/>
          <p:nvPr/>
        </p:nvGrpSpPr>
        <p:grpSpPr>
          <a:xfrm>
            <a:off x="3160875" y="3042711"/>
            <a:ext cx="291507" cy="199711"/>
            <a:chOff x="1583191" y="3040274"/>
            <a:chExt cx="291507" cy="199711"/>
          </a:xfrm>
        </p:grpSpPr>
        <p:sp>
          <p:nvSpPr>
            <p:cNvPr id="55" name="Right Triangle 54">
              <a:extLst>
                <a:ext uri="{FF2B5EF4-FFF2-40B4-BE49-F238E27FC236}">
                  <a16:creationId xmlns:a16="http://schemas.microsoft.com/office/drawing/2014/main" id="{DAEC8F08-22E3-4B43-74EE-02D22C6CD775}"/>
                </a:ext>
              </a:extLst>
            </p:cNvPr>
            <p:cNvSpPr/>
            <p:nvPr/>
          </p:nvSpPr>
          <p:spPr>
            <a:xfrm>
              <a:off x="1583191" y="3040274"/>
              <a:ext cx="291507" cy="57162"/>
            </a:xfrm>
            <a:prstGeom prst="rtTriangle">
              <a:avLst/>
            </a:prstGeom>
            <a:noFill/>
            <a:ln w="63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B96901F9-D96D-B727-A6DA-2EFDB2DF81D5}"/>
                </a:ext>
              </a:extLst>
            </p:cNvPr>
            <p:cNvSpPr txBox="1"/>
            <p:nvPr/>
          </p:nvSpPr>
          <p:spPr>
            <a:xfrm>
              <a:off x="1660851" y="3055319"/>
              <a:ext cx="1042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</p:grpSp>
      <p:grpSp>
        <p:nvGrpSpPr>
          <p:cNvPr id="57" name="Group 56">
            <a:extLst>
              <a:ext uri="{FF2B5EF4-FFF2-40B4-BE49-F238E27FC236}">
                <a16:creationId xmlns:a16="http://schemas.microsoft.com/office/drawing/2014/main" id="{C3F29210-522E-0DDB-1571-EF1C2669BAF5}"/>
              </a:ext>
            </a:extLst>
          </p:cNvPr>
          <p:cNvGrpSpPr/>
          <p:nvPr/>
        </p:nvGrpSpPr>
        <p:grpSpPr>
          <a:xfrm>
            <a:off x="3602497" y="3042711"/>
            <a:ext cx="291507" cy="199711"/>
            <a:chOff x="1583191" y="3040274"/>
            <a:chExt cx="291507" cy="199711"/>
          </a:xfrm>
        </p:grpSpPr>
        <p:sp>
          <p:nvSpPr>
            <p:cNvPr id="58" name="Right Triangle 57">
              <a:extLst>
                <a:ext uri="{FF2B5EF4-FFF2-40B4-BE49-F238E27FC236}">
                  <a16:creationId xmlns:a16="http://schemas.microsoft.com/office/drawing/2014/main" id="{2674B0BE-2B06-2411-D30E-27926CB58320}"/>
                </a:ext>
              </a:extLst>
            </p:cNvPr>
            <p:cNvSpPr/>
            <p:nvPr/>
          </p:nvSpPr>
          <p:spPr>
            <a:xfrm>
              <a:off x="1583191" y="3040274"/>
              <a:ext cx="291507" cy="57162"/>
            </a:xfrm>
            <a:prstGeom prst="rtTriangle">
              <a:avLst/>
            </a:prstGeom>
            <a:noFill/>
            <a:ln w="63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E9166BD8-B0BB-5C5A-69DE-560815630095}"/>
                </a:ext>
              </a:extLst>
            </p:cNvPr>
            <p:cNvSpPr txBox="1"/>
            <p:nvPr/>
          </p:nvSpPr>
          <p:spPr>
            <a:xfrm>
              <a:off x="1660851" y="3055319"/>
              <a:ext cx="1042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</p:grpSp>
      <p:grpSp>
        <p:nvGrpSpPr>
          <p:cNvPr id="60" name="Group 59">
            <a:extLst>
              <a:ext uri="{FF2B5EF4-FFF2-40B4-BE49-F238E27FC236}">
                <a16:creationId xmlns:a16="http://schemas.microsoft.com/office/drawing/2014/main" id="{68EEF223-E5EA-B3A5-84B9-9F4A29ECC1B1}"/>
              </a:ext>
            </a:extLst>
          </p:cNvPr>
          <p:cNvGrpSpPr/>
          <p:nvPr/>
        </p:nvGrpSpPr>
        <p:grpSpPr>
          <a:xfrm>
            <a:off x="4121779" y="3042711"/>
            <a:ext cx="291507" cy="199711"/>
            <a:chOff x="1583191" y="3040274"/>
            <a:chExt cx="291507" cy="199711"/>
          </a:xfrm>
        </p:grpSpPr>
        <p:sp>
          <p:nvSpPr>
            <p:cNvPr id="61" name="Right Triangle 60">
              <a:extLst>
                <a:ext uri="{FF2B5EF4-FFF2-40B4-BE49-F238E27FC236}">
                  <a16:creationId xmlns:a16="http://schemas.microsoft.com/office/drawing/2014/main" id="{F0A71EA3-B1AB-181E-D222-438766875943}"/>
                </a:ext>
              </a:extLst>
            </p:cNvPr>
            <p:cNvSpPr/>
            <p:nvPr/>
          </p:nvSpPr>
          <p:spPr>
            <a:xfrm>
              <a:off x="1583191" y="3040274"/>
              <a:ext cx="291507" cy="57162"/>
            </a:xfrm>
            <a:prstGeom prst="rtTriangle">
              <a:avLst/>
            </a:prstGeom>
            <a:noFill/>
            <a:ln w="63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C6053ECE-F78E-17CA-EDAA-6F1A63277FDE}"/>
                </a:ext>
              </a:extLst>
            </p:cNvPr>
            <p:cNvSpPr txBox="1"/>
            <p:nvPr/>
          </p:nvSpPr>
          <p:spPr>
            <a:xfrm>
              <a:off x="1660851" y="3055319"/>
              <a:ext cx="1042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</p:grpSp>
      <p:grpSp>
        <p:nvGrpSpPr>
          <p:cNvPr id="63" name="Group 62">
            <a:extLst>
              <a:ext uri="{FF2B5EF4-FFF2-40B4-BE49-F238E27FC236}">
                <a16:creationId xmlns:a16="http://schemas.microsoft.com/office/drawing/2014/main" id="{64861A8F-1C7B-32DA-A6B5-FBCB4B523C76}"/>
              </a:ext>
            </a:extLst>
          </p:cNvPr>
          <p:cNvGrpSpPr/>
          <p:nvPr/>
        </p:nvGrpSpPr>
        <p:grpSpPr>
          <a:xfrm>
            <a:off x="4595797" y="3042711"/>
            <a:ext cx="291507" cy="199711"/>
            <a:chOff x="1583191" y="3040274"/>
            <a:chExt cx="291507" cy="199711"/>
          </a:xfrm>
        </p:grpSpPr>
        <p:sp>
          <p:nvSpPr>
            <p:cNvPr id="64" name="Right Triangle 63">
              <a:extLst>
                <a:ext uri="{FF2B5EF4-FFF2-40B4-BE49-F238E27FC236}">
                  <a16:creationId xmlns:a16="http://schemas.microsoft.com/office/drawing/2014/main" id="{6C6043F1-AF5A-DB67-EA51-3C9AE2F39A1D}"/>
                </a:ext>
              </a:extLst>
            </p:cNvPr>
            <p:cNvSpPr/>
            <p:nvPr/>
          </p:nvSpPr>
          <p:spPr>
            <a:xfrm>
              <a:off x="1583191" y="3040274"/>
              <a:ext cx="291507" cy="57162"/>
            </a:xfrm>
            <a:prstGeom prst="rtTriangle">
              <a:avLst/>
            </a:prstGeom>
            <a:noFill/>
            <a:ln w="63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106FF053-DDEC-0222-A5F3-02C03AE7A9FA}"/>
                </a:ext>
              </a:extLst>
            </p:cNvPr>
            <p:cNvSpPr txBox="1"/>
            <p:nvPr/>
          </p:nvSpPr>
          <p:spPr>
            <a:xfrm>
              <a:off x="1660851" y="3055319"/>
              <a:ext cx="1042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</p:grpSp>
      <p:grpSp>
        <p:nvGrpSpPr>
          <p:cNvPr id="66" name="Group 65">
            <a:extLst>
              <a:ext uri="{FF2B5EF4-FFF2-40B4-BE49-F238E27FC236}">
                <a16:creationId xmlns:a16="http://schemas.microsoft.com/office/drawing/2014/main" id="{56E85AA3-B20F-7793-B009-CFB69030544E}"/>
              </a:ext>
            </a:extLst>
          </p:cNvPr>
          <p:cNvGrpSpPr/>
          <p:nvPr/>
        </p:nvGrpSpPr>
        <p:grpSpPr>
          <a:xfrm>
            <a:off x="5169864" y="3042711"/>
            <a:ext cx="291507" cy="199711"/>
            <a:chOff x="1583191" y="3040274"/>
            <a:chExt cx="291507" cy="199711"/>
          </a:xfrm>
        </p:grpSpPr>
        <p:sp>
          <p:nvSpPr>
            <p:cNvPr id="67" name="Right Triangle 66">
              <a:extLst>
                <a:ext uri="{FF2B5EF4-FFF2-40B4-BE49-F238E27FC236}">
                  <a16:creationId xmlns:a16="http://schemas.microsoft.com/office/drawing/2014/main" id="{38DCBE07-7E43-C021-FD85-F13CAAA22698}"/>
                </a:ext>
              </a:extLst>
            </p:cNvPr>
            <p:cNvSpPr/>
            <p:nvPr/>
          </p:nvSpPr>
          <p:spPr>
            <a:xfrm>
              <a:off x="1583191" y="3040274"/>
              <a:ext cx="291507" cy="57162"/>
            </a:xfrm>
            <a:prstGeom prst="rtTriangle">
              <a:avLst/>
            </a:prstGeom>
            <a:noFill/>
            <a:ln w="63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010E70A3-3CFB-65CC-C705-58A197E0F212}"/>
                </a:ext>
              </a:extLst>
            </p:cNvPr>
            <p:cNvSpPr txBox="1"/>
            <p:nvPr/>
          </p:nvSpPr>
          <p:spPr>
            <a:xfrm>
              <a:off x="1660851" y="3055319"/>
              <a:ext cx="1042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</p:grpSp>
      <p:grpSp>
        <p:nvGrpSpPr>
          <p:cNvPr id="69" name="Group 68">
            <a:extLst>
              <a:ext uri="{FF2B5EF4-FFF2-40B4-BE49-F238E27FC236}">
                <a16:creationId xmlns:a16="http://schemas.microsoft.com/office/drawing/2014/main" id="{E44D59A0-FE20-E6ED-DF84-13DF61732831}"/>
              </a:ext>
            </a:extLst>
          </p:cNvPr>
          <p:cNvGrpSpPr/>
          <p:nvPr/>
        </p:nvGrpSpPr>
        <p:grpSpPr>
          <a:xfrm>
            <a:off x="5643882" y="3042711"/>
            <a:ext cx="291507" cy="199711"/>
            <a:chOff x="1583191" y="3040274"/>
            <a:chExt cx="291507" cy="199711"/>
          </a:xfrm>
        </p:grpSpPr>
        <p:sp>
          <p:nvSpPr>
            <p:cNvPr id="70" name="Right Triangle 69">
              <a:extLst>
                <a:ext uri="{FF2B5EF4-FFF2-40B4-BE49-F238E27FC236}">
                  <a16:creationId xmlns:a16="http://schemas.microsoft.com/office/drawing/2014/main" id="{15CCB0E1-B71E-D22C-FC70-0CFC6DBB6C7F}"/>
                </a:ext>
              </a:extLst>
            </p:cNvPr>
            <p:cNvSpPr/>
            <p:nvPr/>
          </p:nvSpPr>
          <p:spPr>
            <a:xfrm>
              <a:off x="1583191" y="3040274"/>
              <a:ext cx="291507" cy="57162"/>
            </a:xfrm>
            <a:prstGeom prst="rtTriangle">
              <a:avLst/>
            </a:prstGeom>
            <a:noFill/>
            <a:ln w="63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382E0FCF-2EF2-F8BA-EE4E-60A66D396D2D}"/>
                </a:ext>
              </a:extLst>
            </p:cNvPr>
            <p:cNvSpPr txBox="1"/>
            <p:nvPr/>
          </p:nvSpPr>
          <p:spPr>
            <a:xfrm>
              <a:off x="1660851" y="3055319"/>
              <a:ext cx="1042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418516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29</Words>
  <Application>Microsoft Macintosh PowerPoint</Application>
  <PresentationFormat>A4 Paper (210x297 mm)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va Herrero Serrano</dc:creator>
  <cp:lastModifiedBy>Eva Herrero Serrano</cp:lastModifiedBy>
  <cp:revision>2</cp:revision>
  <cp:lastPrinted>2025-07-02T13:25:36Z</cp:lastPrinted>
  <dcterms:created xsi:type="dcterms:W3CDTF">2024-05-20T09:44:22Z</dcterms:created>
  <dcterms:modified xsi:type="dcterms:W3CDTF">2025-07-02T13:30:33Z</dcterms:modified>
</cp:coreProperties>
</file>